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78" r:id="rId2"/>
    <p:sldId id="379" r:id="rId3"/>
  </p:sldIdLst>
  <p:sldSz cx="9906000" cy="6858000" type="A4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20F0"/>
    <a:srgbClr val="FFFF00"/>
    <a:srgbClr val="0000FF"/>
    <a:srgbClr val="DAA600"/>
    <a:srgbClr val="ACA800"/>
    <a:srgbClr val="C06000"/>
    <a:srgbClr val="E6BA00"/>
    <a:srgbClr val="00CC00"/>
    <a:srgbClr val="0066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7355436-D6C9-484F-A5BE-78577E542397}" v="4" dt="2025-10-27T23:28:50.2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548" y="9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restha, Avinash" userId="5add98df-411e-49d5-8233-8d4857106cf3" providerId="ADAL" clId="{B598BFAD-5F30-4432-A8E7-25629D7821CF}"/>
    <pc:docChg chg="undo custSel addSld modSld">
      <pc:chgData name="Shrestha, Avinash" userId="5add98df-411e-49d5-8233-8d4857106cf3" providerId="ADAL" clId="{B598BFAD-5F30-4432-A8E7-25629D7821CF}" dt="2025-10-27T23:28:50.218" v="23"/>
      <pc:docMkLst>
        <pc:docMk/>
      </pc:docMkLst>
      <pc:sldChg chg="addSp delSp modSp mod">
        <pc:chgData name="Shrestha, Avinash" userId="5add98df-411e-49d5-8233-8d4857106cf3" providerId="ADAL" clId="{B598BFAD-5F30-4432-A8E7-25629D7821CF}" dt="2025-10-27T23:28:20.278" v="22" actId="1076"/>
        <pc:sldMkLst>
          <pc:docMk/>
          <pc:sldMk cId="2100341470" sldId="378"/>
        </pc:sldMkLst>
        <pc:spChg chg="add mod">
          <ac:chgData name="Shrestha, Avinash" userId="5add98df-411e-49d5-8233-8d4857106cf3" providerId="ADAL" clId="{B598BFAD-5F30-4432-A8E7-25629D7821CF}" dt="2025-10-23T23:49:38.365" v="10" actId="1076"/>
          <ac:spMkLst>
            <pc:docMk/>
            <pc:sldMk cId="2100341470" sldId="378"/>
            <ac:spMk id="3" creationId="{CDBAE5E2-33DD-995D-4525-C5B46A473D15}"/>
          </ac:spMkLst>
        </pc:spChg>
        <pc:picChg chg="add del mod">
          <ac:chgData name="Shrestha, Avinash" userId="5add98df-411e-49d5-8233-8d4857106cf3" providerId="ADAL" clId="{B598BFAD-5F30-4432-A8E7-25629D7821CF}" dt="2025-10-27T23:28:20.278" v="22" actId="1076"/>
          <ac:picMkLst>
            <pc:docMk/>
            <pc:sldMk cId="2100341470" sldId="378"/>
            <ac:picMk id="12" creationId="{761AF689-D619-44C6-0DFA-92D3929BDC32}"/>
          </ac:picMkLst>
        </pc:picChg>
      </pc:sldChg>
      <pc:sldChg chg="add">
        <pc:chgData name="Shrestha, Avinash" userId="5add98df-411e-49d5-8233-8d4857106cf3" providerId="ADAL" clId="{B598BFAD-5F30-4432-A8E7-25629D7821CF}" dt="2025-10-27T23:28:50.218" v="23"/>
        <pc:sldMkLst>
          <pc:docMk/>
          <pc:sldMk cId="3337230414" sldId="379"/>
        </pc:sldMkLst>
      </pc:sldChg>
    </pc:docChg>
  </pc:docChgLst>
  <pc:docChgLst>
    <pc:chgData name="Shrestha, Avinash" userId="5add98df-411e-49d5-8233-8d4857106cf3" providerId="ADAL" clId="{2E4E0AE3-1203-40B4-B76C-7630C6AFF160}"/>
    <pc:docChg chg="modSld">
      <pc:chgData name="Shrestha, Avinash" userId="5add98df-411e-49d5-8233-8d4857106cf3" providerId="ADAL" clId="{2E4E0AE3-1203-40B4-B76C-7630C6AFF160}" dt="2025-10-28T00:24:11.320" v="0" actId="20577"/>
      <pc:docMkLst>
        <pc:docMk/>
      </pc:docMkLst>
      <pc:sldChg chg="modSp mod">
        <pc:chgData name="Shrestha, Avinash" userId="5add98df-411e-49d5-8233-8d4857106cf3" providerId="ADAL" clId="{2E4E0AE3-1203-40B4-B76C-7630C6AFF160}" dt="2025-10-28T00:24:11.320" v="0" actId="20577"/>
        <pc:sldMkLst>
          <pc:docMk/>
          <pc:sldMk cId="2100341470" sldId="378"/>
        </pc:sldMkLst>
        <pc:spChg chg="mod">
          <ac:chgData name="Shrestha, Avinash" userId="5add98df-411e-49d5-8233-8d4857106cf3" providerId="ADAL" clId="{2E4E0AE3-1203-40B4-B76C-7630C6AFF160}" dt="2025-10-28T00:24:11.320" v="0" actId="20577"/>
          <ac:spMkLst>
            <pc:docMk/>
            <pc:sldMk cId="2100341470" sldId="378"/>
            <ac:spMk id="3" creationId="{CDBAE5E2-33DD-995D-4525-C5B46A473D1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18A880-FBBD-4631-B292-454E4629069F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6338" y="1162050"/>
            <a:ext cx="45307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712613-E2D8-4E40-8AA9-ECC1EDC6B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47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701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3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83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833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104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905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7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917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447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90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313A-9239-46AE-8E81-9652ADF8B2E0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graph of different colored bars&#10;&#10;AI-generated content may be incorrect.">
            <a:extLst>
              <a:ext uri="{FF2B5EF4-FFF2-40B4-BE49-F238E27FC236}">
                <a16:creationId xmlns:a16="http://schemas.microsoft.com/office/drawing/2014/main" id="{761AF689-D619-44C6-0DFA-92D3929BDC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191" y="564478"/>
            <a:ext cx="8229617" cy="438912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DBAE5E2-33DD-995D-4525-C5B46A473D15}"/>
              </a:ext>
            </a:extLst>
          </p:cNvPr>
          <p:cNvSpPr txBox="1"/>
          <p:nvPr/>
        </p:nvSpPr>
        <p:spPr>
          <a:xfrm>
            <a:off x="1199583" y="5822740"/>
            <a:ext cx="82296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-wise SNP counts for the final filtered dataset show broad coverage across the A and 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genom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100341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screenshot of a computer&#10;&#10;AI-generated content may be incorrect.">
            <a:extLst>
              <a:ext uri="{FF2B5EF4-FFF2-40B4-BE49-F238E27FC236}">
                <a16:creationId xmlns:a16="http://schemas.microsoft.com/office/drawing/2014/main" id="{1B8545EB-E0F8-7C8C-6528-BBDE615DF5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353" y="358082"/>
            <a:ext cx="9243588" cy="577724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2B790E7-8110-0641-5357-002C5AC1BF53}"/>
              </a:ext>
            </a:extLst>
          </p:cNvPr>
          <p:cNvSpPr txBox="1"/>
          <p:nvPr/>
        </p:nvSpPr>
        <p:spPr>
          <a:xfrm>
            <a:off x="145609" y="6269085"/>
            <a:ext cx="9614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onal distribution of SNPs along each chromosome in the final filtered dataset. Counts are computed in equal-width bins (n = 200 bins per chromosome) across the observed physical span; facets show per-chromosome SNP density.</a:t>
            </a:r>
          </a:p>
        </p:txBody>
      </p:sp>
    </p:spTree>
    <p:extLst>
      <p:ext uri="{BB962C8B-B14F-4D97-AF65-F5344CB8AC3E}">
        <p14:creationId xmlns:p14="http://schemas.microsoft.com/office/powerpoint/2010/main" val="3337230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230</TotalTime>
  <Words>63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Times New Roman</vt:lpstr>
      <vt:lpstr>Office 2013 - 2022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isk</dc:creator>
  <cp:lastModifiedBy>Shrestha, Avinash</cp:lastModifiedBy>
  <cp:revision>13</cp:revision>
  <cp:lastPrinted>2024-11-20T18:37:47Z</cp:lastPrinted>
  <dcterms:created xsi:type="dcterms:W3CDTF">2016-05-26T16:30:45Z</dcterms:created>
  <dcterms:modified xsi:type="dcterms:W3CDTF">2025-10-28T00:24:15Z</dcterms:modified>
</cp:coreProperties>
</file>